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  <p:sldMasterId id="2147483648" r:id="rId2"/>
  </p:sldMasterIdLst>
  <p:sldIdLst>
    <p:sldId id="261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23CDBB8-3300-4C71-AC66-7F8AB0540064}" v="8" dt="2022-07-14T13:46:47.63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965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448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slide" Target="slides/slide1.xml"/><Relationship Id="rId7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53878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29054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944565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12D051-B7CB-054E-9A52-D33D24AD6FC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4B756A0-FCD3-884F-ACDD-4AD11B4EEB4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CFB9B6-F1A4-CD48-9BDC-6C354CA44E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95AC7-7209-BB4D-B81F-39D9B877AFEE}" type="datetimeFigureOut">
              <a:rPr lang="en-US" smtClean="0"/>
              <a:t>9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CF29E6-5EB2-CE41-A04C-5A39C17CAD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AB3CAD-4474-8049-A46F-5BFEF9F097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B9A71-8A8F-7642-867C-57A7B68A91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206919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96BD2E-0B58-224B-A193-406981071B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73E9FBC-A370-1B44-AF3F-91C8C7DD957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2934D9-CAA6-424A-8597-E298B12590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95AC7-7209-BB4D-B81F-39D9B877AFEE}" type="datetimeFigureOut">
              <a:rPr lang="en-US" smtClean="0"/>
              <a:t>9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4CE521-DACA-2F4F-AE7C-568689FC7B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5DF547-F2F2-0A43-B22D-A8A25CAD66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B9A71-8A8F-7642-867C-57A7B68A91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151171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C610A5-9FC5-804A-8301-B9E9C34369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C958608-E482-9643-948F-78117A1EAE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6BE03F-8988-9943-955F-B291150C8E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95AC7-7209-BB4D-B81F-39D9B877AFEE}" type="datetimeFigureOut">
              <a:rPr lang="en-US" smtClean="0"/>
              <a:t>9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DB4B6C-133F-A24C-8375-A094CFCEDD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30E318-E0D4-7F49-B2BD-D4B0C7B0C6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B9A71-8A8F-7642-867C-57A7B68A91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237785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217D13-AFBE-E746-A6AF-E21B973194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C14BB83-ACB2-3443-81FC-3A8994A5763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1EB9408-F349-E24E-9859-F23D8D1C226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24C684E-4F0F-F74D-AACB-3028C3DF51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95AC7-7209-BB4D-B81F-39D9B877AFEE}" type="datetimeFigureOut">
              <a:rPr lang="en-US" smtClean="0"/>
              <a:t>9/26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D1B2D46-80C3-7E44-907F-77302C1A4B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1B38C06-5C74-AE4D-ABBE-5767F25C87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B9A71-8A8F-7642-867C-57A7B68A91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1750667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727B76-F63C-C145-8461-1BE46AD1C0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727D958-D739-1C48-8723-2FC7B37267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1734B83-6E83-1F41-A2F4-9D0817CEA2E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04D9504-B80C-7F4F-A56E-45577C3ECBC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3556560-B37C-224D-A5DB-0D6482C9A49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0B95C60-3E7D-2140-9B06-42EBF4F8B0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95AC7-7209-BB4D-B81F-39D9B877AFEE}" type="datetimeFigureOut">
              <a:rPr lang="en-US" smtClean="0"/>
              <a:t>9/26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E1649AE-840B-034C-9B38-0D64D4D923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AEE22F9-6DC8-0945-B1F8-D49C029A6C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B9A71-8A8F-7642-867C-57A7B68A91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0593710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BC3AAA-38BB-A649-8588-D5537A22FB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3D9B666-FA92-A840-90D2-6F9F7E781E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95AC7-7209-BB4D-B81F-39D9B877AFEE}" type="datetimeFigureOut">
              <a:rPr lang="en-US" smtClean="0"/>
              <a:t>9/26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3CE7815-B821-7649-AABA-F40EB27C49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4E0D425-F3BD-FC41-96DF-D82F3B1A0E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B9A71-8A8F-7642-867C-57A7B68A91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2523287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55F148C-E3AC-4943-A931-D167425D22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95AC7-7209-BB4D-B81F-39D9B877AFEE}" type="datetimeFigureOut">
              <a:rPr lang="en-US" smtClean="0"/>
              <a:t>9/26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DE0678F-F8DB-7F46-B449-0EDA59DB85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192DBEC-76EE-6D4D-8D29-14AF946DA2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B9A71-8A8F-7642-867C-57A7B68A91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2702057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E50BAD-335A-CA47-9556-92E731A8AD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E50E9D6-DF18-FC42-905A-F38AEE3B747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78A4527-4536-A340-B88B-4CABB91E114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570A2B4-4476-C24D-BB7D-52DA22D8B1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95AC7-7209-BB4D-B81F-39D9B877AFEE}" type="datetimeFigureOut">
              <a:rPr lang="en-US" smtClean="0"/>
              <a:t>9/26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0A56319-EA4A-1944-80D8-8F5B9B5865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DFD6F76-DABC-904A-8E45-8713B139FE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B9A71-8A8F-7642-867C-57A7B68A91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06277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9138452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FB76F9-08E9-164E-84DB-869597E49A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012E3B0-0E06-7346-ABDD-8D7CC060403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4FDD8E9-EB4B-E84E-A522-525E2B0B559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46283E3-6682-2E45-BEB5-5C425EAD51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95AC7-7209-BB4D-B81F-39D9B877AFEE}" type="datetimeFigureOut">
              <a:rPr lang="en-US" smtClean="0"/>
              <a:t>9/26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2E93C28-2330-C34F-8F27-6D07A5C98F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4F89BE6-A67B-1D49-8535-B9AB99F3A8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B9A71-8A8F-7642-867C-57A7B68A91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181114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CC76DF-5795-CB43-92C1-DF2445A652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45F5D94-BD5F-5F4D-A538-25759B4EB1D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73CF15-20B4-F848-8C68-BF75AC61F7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95AC7-7209-BB4D-B81F-39D9B877AFEE}" type="datetimeFigureOut">
              <a:rPr lang="en-US" smtClean="0"/>
              <a:t>9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AE1280-3B9C-8C4B-A629-0475E70B0A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52E84E-AF5A-124D-9215-3D24E43C67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B9A71-8A8F-7642-867C-57A7B68A91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0669268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77FCA8E-DE1D-3340-A7FD-9554846BB21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365B267-4149-E347-9C39-96476A361AC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B82ADE-D3A4-2541-9EB4-A8B3E9651C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95AC7-7209-BB4D-B81F-39D9B877AFEE}" type="datetimeFigureOut">
              <a:rPr lang="en-US" smtClean="0"/>
              <a:t>9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810EAE-0823-474A-9DD9-63AAD05035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AFC3867-04C8-8147-BE0E-20C8EC9B09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B9A71-8A8F-7642-867C-57A7B68A91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37820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15245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6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30920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6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31723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6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03125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6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3889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6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1841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6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89582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6CE7D5-CF57-46EF-B807-FDD0502418D4}" type="datetimeFigureOut">
              <a:rPr lang="en-US" smtClean="0"/>
              <a:t>9/2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9540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F0CA3C8-A7D6-6F4B-99D2-3C6B0F4D44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ECB8835-D1EA-3943-B15C-C87EDA3DA6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783261-A60F-694D-A70F-0C469D3FBCA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795AC7-7209-BB4D-B81F-39D9B877AFEE}" type="datetimeFigureOut">
              <a:rPr lang="en-US" smtClean="0"/>
              <a:t>9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F98DDF-253A-8648-AFC3-0F58D63951D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B8B7980-EBD6-C74D-80A2-7783BA19B2B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4B9A71-8A8F-7642-867C-57A7B68A91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15172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853BC96B-87DF-1297-6BDE-D0E5B77720A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9636" t="11904" r="26242" b="27382"/>
          <a:stretch/>
        </p:blipFill>
        <p:spPr>
          <a:xfrm flipH="1">
            <a:off x="3509935" y="156673"/>
            <a:ext cx="7429500" cy="667085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BC6C931F-EBB7-0AB8-1E69-62FD766A979C}"/>
              </a:ext>
            </a:extLst>
          </p:cNvPr>
          <p:cNvSpPr txBox="1"/>
          <p:nvPr/>
        </p:nvSpPr>
        <p:spPr>
          <a:xfrm>
            <a:off x="2468152" y="816430"/>
            <a:ext cx="930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as7-1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E1AFD1B-B984-D3F5-3CB9-34CC4C5DCA41}"/>
              </a:ext>
            </a:extLst>
          </p:cNvPr>
          <p:cNvSpPr txBox="1"/>
          <p:nvPr/>
        </p:nvSpPr>
        <p:spPr>
          <a:xfrm>
            <a:off x="2548301" y="1125826"/>
            <a:ext cx="769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RN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8E57613-45AD-0CA5-4D0F-89933E0FBE77}"/>
              </a:ext>
            </a:extLst>
          </p:cNvPr>
          <p:cNvSpPr txBox="1"/>
          <p:nvPr/>
        </p:nvSpPr>
        <p:spPr>
          <a:xfrm>
            <a:off x="2229316" y="1435222"/>
            <a:ext cx="12247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arget RN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F19E49C-3C90-4997-6B55-AE7A0E20F404}"/>
              </a:ext>
            </a:extLst>
          </p:cNvPr>
          <p:cNvSpPr txBox="1"/>
          <p:nvPr/>
        </p:nvSpPr>
        <p:spPr>
          <a:xfrm>
            <a:off x="2723230" y="1744618"/>
            <a:ext cx="6642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DT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202CD6F-F93D-D898-E70A-43248DF4D81F}"/>
              </a:ext>
            </a:extLst>
          </p:cNvPr>
          <p:cNvSpPr txBox="1"/>
          <p:nvPr/>
        </p:nvSpPr>
        <p:spPr>
          <a:xfrm>
            <a:off x="4718249" y="1065890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4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A653545-EC3D-2F27-5D26-99C08651E1AA}"/>
              </a:ext>
            </a:extLst>
          </p:cNvPr>
          <p:cNvSpPr txBox="1"/>
          <p:nvPr/>
        </p:nvSpPr>
        <p:spPr>
          <a:xfrm>
            <a:off x="5213057" y="1065890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9AE24CC-743B-DBB3-40C1-D60CD0D8CE30}"/>
              </a:ext>
            </a:extLst>
          </p:cNvPr>
          <p:cNvSpPr txBox="1"/>
          <p:nvPr/>
        </p:nvSpPr>
        <p:spPr>
          <a:xfrm>
            <a:off x="5750366" y="1109497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8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EA507F1-7859-A686-0426-D4D497D0F6DC}"/>
              </a:ext>
            </a:extLst>
          </p:cNvPr>
          <p:cNvSpPr txBox="1"/>
          <p:nvPr/>
        </p:nvSpPr>
        <p:spPr>
          <a:xfrm>
            <a:off x="6160315" y="1103273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4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1F3B6CE-AE8B-DCC7-8FDD-CFA96EC4B597}"/>
              </a:ext>
            </a:extLst>
          </p:cNvPr>
          <p:cNvSpPr txBox="1"/>
          <p:nvPr/>
        </p:nvSpPr>
        <p:spPr>
          <a:xfrm>
            <a:off x="6655123" y="1103273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8A92FE7-7185-5E1A-967E-F7F85E14BAD6}"/>
              </a:ext>
            </a:extLst>
          </p:cNvPr>
          <p:cNvSpPr txBox="1"/>
          <p:nvPr/>
        </p:nvSpPr>
        <p:spPr>
          <a:xfrm>
            <a:off x="7112036" y="111422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8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F8F4427-17FC-2089-0E57-BFE19FBDFD92}"/>
              </a:ext>
            </a:extLst>
          </p:cNvPr>
          <p:cNvSpPr txBox="1"/>
          <p:nvPr/>
        </p:nvSpPr>
        <p:spPr>
          <a:xfrm>
            <a:off x="4836871" y="137528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913925D-0654-1636-06C9-61AE0A72DDE5}"/>
              </a:ext>
            </a:extLst>
          </p:cNvPr>
          <p:cNvSpPr txBox="1"/>
          <p:nvPr/>
        </p:nvSpPr>
        <p:spPr>
          <a:xfrm>
            <a:off x="5272313" y="139479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7453B4B-D835-71DE-6647-DB7B988CD83C}"/>
              </a:ext>
            </a:extLst>
          </p:cNvPr>
          <p:cNvSpPr txBox="1"/>
          <p:nvPr/>
        </p:nvSpPr>
        <p:spPr>
          <a:xfrm>
            <a:off x="5743481" y="143522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2BC0B94-D650-E6BB-2574-9618D9E6AEDC}"/>
              </a:ext>
            </a:extLst>
          </p:cNvPr>
          <p:cNvSpPr txBox="1"/>
          <p:nvPr/>
        </p:nvSpPr>
        <p:spPr>
          <a:xfrm>
            <a:off x="6209801" y="1427305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F7282D5-B5B7-FC78-DBD2-B5A395AE89C9}"/>
              </a:ext>
            </a:extLst>
          </p:cNvPr>
          <p:cNvSpPr txBox="1"/>
          <p:nvPr/>
        </p:nvSpPr>
        <p:spPr>
          <a:xfrm>
            <a:off x="6719552" y="1409803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CC1E07C-F9B4-58E8-2AF0-F48B255FF1AE}"/>
              </a:ext>
            </a:extLst>
          </p:cNvPr>
          <p:cNvSpPr txBox="1"/>
          <p:nvPr/>
        </p:nvSpPr>
        <p:spPr>
          <a:xfrm>
            <a:off x="7133455" y="143522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81E312E-A645-EF1E-9186-7E41E7DD7937}"/>
              </a:ext>
            </a:extLst>
          </p:cNvPr>
          <p:cNvSpPr txBox="1"/>
          <p:nvPr/>
        </p:nvSpPr>
        <p:spPr>
          <a:xfrm>
            <a:off x="4201952" y="1083886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4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FE2B5CA-73E9-927D-47C0-A976EDE31B57}"/>
              </a:ext>
            </a:extLst>
          </p:cNvPr>
          <p:cNvSpPr txBox="1"/>
          <p:nvPr/>
        </p:nvSpPr>
        <p:spPr>
          <a:xfrm>
            <a:off x="4288734" y="1394647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AC1B5A5B-D097-65AF-491E-A4A003922BC8}"/>
              </a:ext>
            </a:extLst>
          </p:cNvPr>
          <p:cNvSpPr txBox="1"/>
          <p:nvPr/>
        </p:nvSpPr>
        <p:spPr>
          <a:xfrm>
            <a:off x="4288734" y="1705408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-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890D3D1-A476-933B-253A-E839D820AA5D}"/>
              </a:ext>
            </a:extLst>
          </p:cNvPr>
          <p:cNvSpPr txBox="1"/>
          <p:nvPr/>
        </p:nvSpPr>
        <p:spPr>
          <a:xfrm>
            <a:off x="4815738" y="1705408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-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9D7D3692-E87A-A4AF-E068-6A61AD211BD7}"/>
              </a:ext>
            </a:extLst>
          </p:cNvPr>
          <p:cNvSpPr txBox="1"/>
          <p:nvPr/>
        </p:nvSpPr>
        <p:spPr>
          <a:xfrm>
            <a:off x="5305036" y="1728289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-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995D8D34-E3D0-C7CA-BEB5-DF347F0CBEE0}"/>
              </a:ext>
            </a:extLst>
          </p:cNvPr>
          <p:cNvSpPr txBox="1"/>
          <p:nvPr/>
        </p:nvSpPr>
        <p:spPr>
          <a:xfrm>
            <a:off x="5778458" y="1728289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-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5A710EAA-633B-62C8-9E89-45232BE66487}"/>
              </a:ext>
            </a:extLst>
          </p:cNvPr>
          <p:cNvSpPr txBox="1"/>
          <p:nvPr/>
        </p:nvSpPr>
        <p:spPr>
          <a:xfrm>
            <a:off x="6190262" y="1728289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CE57817C-CF25-09BE-8A79-D433ECC5F8D8}"/>
              </a:ext>
            </a:extLst>
          </p:cNvPr>
          <p:cNvSpPr txBox="1"/>
          <p:nvPr/>
        </p:nvSpPr>
        <p:spPr>
          <a:xfrm>
            <a:off x="6646950" y="1728289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C821CF1F-7761-BC82-934E-E7CA9FA12B1E}"/>
              </a:ext>
            </a:extLst>
          </p:cNvPr>
          <p:cNvSpPr txBox="1"/>
          <p:nvPr/>
        </p:nvSpPr>
        <p:spPr>
          <a:xfrm>
            <a:off x="7113640" y="170540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1FCCDDE0-49A4-1D53-C5D2-64A0F08208F2}"/>
              </a:ext>
            </a:extLst>
          </p:cNvPr>
          <p:cNvSpPr txBox="1"/>
          <p:nvPr/>
        </p:nvSpPr>
        <p:spPr>
          <a:xfrm>
            <a:off x="2076284" y="2934491"/>
            <a:ext cx="144142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arget RNA</a:t>
            </a:r>
          </a:p>
          <a:p>
            <a:r>
              <a:rPr lang="en-US" dirty="0"/>
              <a:t>(cy3 labelled)</a:t>
            </a:r>
          </a:p>
        </p:txBody>
      </p:sp>
      <p:sp>
        <p:nvSpPr>
          <p:cNvPr id="34" name="Right Brace 33">
            <a:extLst>
              <a:ext uri="{FF2B5EF4-FFF2-40B4-BE49-F238E27FC236}">
                <a16:creationId xmlns:a16="http://schemas.microsoft.com/office/drawing/2014/main" id="{2EE01420-5425-B69C-4E03-B3F337CEBB3A}"/>
              </a:ext>
            </a:extLst>
          </p:cNvPr>
          <p:cNvSpPr/>
          <p:nvPr/>
        </p:nvSpPr>
        <p:spPr>
          <a:xfrm rot="10800000">
            <a:off x="3298539" y="3624056"/>
            <a:ext cx="211396" cy="649891"/>
          </a:xfrm>
          <a:prstGeom prst="rightBrace">
            <a:avLst/>
          </a:prstGeom>
          <a:ln w="222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670085A4-8CCC-55FF-2938-6A3252271707}"/>
              </a:ext>
            </a:extLst>
          </p:cNvPr>
          <p:cNvSpPr txBox="1"/>
          <p:nvPr/>
        </p:nvSpPr>
        <p:spPr>
          <a:xfrm>
            <a:off x="1550506" y="3764336"/>
            <a:ext cx="171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leaved product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A110C37D-CD90-10E2-9D00-1036467D794C}"/>
              </a:ext>
            </a:extLst>
          </p:cNvPr>
          <p:cNvSpPr txBox="1"/>
          <p:nvPr/>
        </p:nvSpPr>
        <p:spPr>
          <a:xfrm>
            <a:off x="348109" y="2363410"/>
            <a:ext cx="28616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 </a:t>
            </a:r>
            <a:r>
              <a:rPr lang="en-US" dirty="0" err="1"/>
              <a:t>crRNA:target</a:t>
            </a:r>
            <a:r>
              <a:rPr lang="en-US" dirty="0"/>
              <a:t> RNA complex</a:t>
            </a:r>
          </a:p>
        </p:txBody>
      </p:sp>
      <p:sp>
        <p:nvSpPr>
          <p:cNvPr id="37" name="Right Brace 36">
            <a:extLst>
              <a:ext uri="{FF2B5EF4-FFF2-40B4-BE49-F238E27FC236}">
                <a16:creationId xmlns:a16="http://schemas.microsoft.com/office/drawing/2014/main" id="{FE0EB599-DFC8-45DD-E9A3-E27EDA24834A}"/>
              </a:ext>
            </a:extLst>
          </p:cNvPr>
          <p:cNvSpPr/>
          <p:nvPr/>
        </p:nvSpPr>
        <p:spPr>
          <a:xfrm rot="10800000">
            <a:off x="3270609" y="2333751"/>
            <a:ext cx="211396" cy="492134"/>
          </a:xfrm>
          <a:prstGeom prst="rightBrace">
            <a:avLst/>
          </a:prstGeom>
          <a:ln w="222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F1D9662C-DF29-790C-3FD6-EBD074F75764}"/>
              </a:ext>
            </a:extLst>
          </p:cNvPr>
          <p:cNvSpPr txBox="1"/>
          <p:nvPr/>
        </p:nvSpPr>
        <p:spPr>
          <a:xfrm>
            <a:off x="4281321" y="746375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-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15BB42BD-7EF2-D2A2-2F80-A409CA9B5C4F}"/>
              </a:ext>
            </a:extLst>
          </p:cNvPr>
          <p:cNvSpPr txBox="1"/>
          <p:nvPr/>
        </p:nvSpPr>
        <p:spPr>
          <a:xfrm>
            <a:off x="4802456" y="750939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2CF69F46-8EE3-D15B-BA6F-396FF837071B}"/>
              </a:ext>
            </a:extLst>
          </p:cNvPr>
          <p:cNvSpPr txBox="1"/>
          <p:nvPr/>
        </p:nvSpPr>
        <p:spPr>
          <a:xfrm>
            <a:off x="5237898" y="770445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86A607D7-7541-E5F3-89EC-7B7D34C29AC9}"/>
              </a:ext>
            </a:extLst>
          </p:cNvPr>
          <p:cNvSpPr txBox="1"/>
          <p:nvPr/>
        </p:nvSpPr>
        <p:spPr>
          <a:xfrm>
            <a:off x="5709066" y="810875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DC398E65-A5AD-6E58-F191-67D3EC0DB56C}"/>
              </a:ext>
            </a:extLst>
          </p:cNvPr>
          <p:cNvSpPr txBox="1"/>
          <p:nvPr/>
        </p:nvSpPr>
        <p:spPr>
          <a:xfrm>
            <a:off x="6175386" y="80295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1C3BDAA6-79EE-74CE-B37A-63613BF4CF92}"/>
              </a:ext>
            </a:extLst>
          </p:cNvPr>
          <p:cNvSpPr txBox="1"/>
          <p:nvPr/>
        </p:nvSpPr>
        <p:spPr>
          <a:xfrm>
            <a:off x="6685137" y="78545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96D0CDA8-56CE-60CE-8E3B-C9A57379015F}"/>
              </a:ext>
            </a:extLst>
          </p:cNvPr>
          <p:cNvSpPr txBox="1"/>
          <p:nvPr/>
        </p:nvSpPr>
        <p:spPr>
          <a:xfrm>
            <a:off x="7099040" y="810875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1C713AD8-EB15-2422-D272-D276C52A506C}"/>
              </a:ext>
            </a:extLst>
          </p:cNvPr>
          <p:cNvSpPr txBox="1"/>
          <p:nvPr/>
        </p:nvSpPr>
        <p:spPr>
          <a:xfrm>
            <a:off x="25626" y="0"/>
            <a:ext cx="143981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b="1" dirty="0"/>
              <a:t>Fig. 2d</a:t>
            </a:r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6DC4CC64-ABCF-200F-3A42-54574579297A}"/>
              </a:ext>
            </a:extLst>
          </p:cNvPr>
          <p:cNvSpPr/>
          <p:nvPr/>
        </p:nvSpPr>
        <p:spPr>
          <a:xfrm>
            <a:off x="4135946" y="2095035"/>
            <a:ext cx="3263176" cy="3105327"/>
          </a:xfrm>
          <a:prstGeom prst="rect">
            <a:avLst/>
          </a:prstGeom>
          <a:noFill/>
          <a:ln w="38100">
            <a:solidFill>
              <a:schemeClr val="accent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40485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0</Words>
  <Application>Microsoft Macintosh PowerPoint</Application>
  <PresentationFormat>Widescreen</PresentationFormat>
  <Paragraphs>3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/>
  <cp:lastModifiedBy>Hemant Goswami</cp:lastModifiedBy>
  <cp:revision>10</cp:revision>
  <dcterms:created xsi:type="dcterms:W3CDTF">2022-07-14T13:44:23Z</dcterms:created>
  <dcterms:modified xsi:type="dcterms:W3CDTF">2022-09-26T19:30:23Z</dcterms:modified>
</cp:coreProperties>
</file>